
<file path=[Content_Types].xml><?xml version="1.0" encoding="utf-8"?>
<Types xmlns="http://schemas.openxmlformats.org/package/2006/content-types"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3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sldIdLst>
    <p:sldId id="257" r:id="rId3"/>
    <p:sldId id="256" r:id="rId4"/>
    <p:sldId id="259" r:id="rId5"/>
    <p:sldId id="260" r:id="rId6"/>
  </p:sldIdLst>
  <p:sldSz cx="12192000" cy="6858000"/>
  <p:notesSz cx="6858000" cy="9144000"/>
  <p:defaultTextStyle>
    <a:defPPr>
      <a:defRPr lang="fi-FI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00" autoAdjust="0"/>
    <p:restoredTop sz="94660"/>
  </p:normalViewPr>
  <p:slideViewPr>
    <p:cSldViewPr snapToGrid="0">
      <p:cViewPr varScale="1">
        <p:scale>
          <a:sx n="83" d="100"/>
          <a:sy n="83" d="100"/>
        </p:scale>
        <p:origin x="456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1.xml"/><Relationship Id="rId7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10" Type="http://schemas.openxmlformats.org/officeDocument/2006/relationships/tableStyles" Target="tableStyles.xml"/><Relationship Id="rId4" Type="http://schemas.openxmlformats.org/officeDocument/2006/relationships/slide" Target="slides/slide2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package" Target="../embeddings/Microsoft_Excel_Worksheet1.xlsx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package" Target="../embeddings/Microsoft_Excel_Worksheet2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fi-FI"/>
              <a:t>ALL</a:t>
            </a:r>
            <a:r>
              <a:rPr lang="fi-FI" baseline="0"/>
              <a:t> (N=177)</a:t>
            </a:r>
            <a:endParaRPr lang="fi-FI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i-FI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tästä 030723'!$C$4</c:f>
              <c:strCache>
                <c:ptCount val="1"/>
                <c:pt idx="0">
                  <c:v>0</c:v>
                </c:pt>
              </c:strCache>
            </c:strRef>
          </c:tx>
          <c:spPr>
            <a:ln w="19050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19050">
                <a:solidFill>
                  <a:sysClr val="windowText" lastClr="000000"/>
                </a:solidFill>
                <a:prstDash val="solid"/>
              </a:ln>
              <a:effectLst/>
            </c:spPr>
          </c:marker>
          <c:cat>
            <c:strRef>
              <c:f>'tästä 030723'!$B$5:$B$19</c:f>
              <c:strCache>
                <c:ptCount val="15"/>
                <c:pt idx="0">
                  <c:v>MOVE</c:v>
                </c:pt>
                <c:pt idx="1">
                  <c:v>SEE*</c:v>
                </c:pt>
                <c:pt idx="2">
                  <c:v>HEAR</c:v>
                </c:pt>
                <c:pt idx="3">
                  <c:v>BREATH</c:v>
                </c:pt>
                <c:pt idx="4">
                  <c:v>SLEEP*</c:v>
                </c:pt>
                <c:pt idx="5">
                  <c:v>EAT</c:v>
                </c:pt>
                <c:pt idx="6">
                  <c:v>SPEECH</c:v>
                </c:pt>
                <c:pt idx="7">
                  <c:v>EXCRET</c:v>
                </c:pt>
                <c:pt idx="8">
                  <c:v>UACT</c:v>
                </c:pt>
                <c:pt idx="9">
                  <c:v>MENTAL</c:v>
                </c:pt>
                <c:pt idx="10">
                  <c:v>DISCO</c:v>
                </c:pt>
                <c:pt idx="11">
                  <c:v>DEPR</c:v>
                </c:pt>
                <c:pt idx="12">
                  <c:v>DISTR</c:v>
                </c:pt>
                <c:pt idx="13">
                  <c:v>VITAL**</c:v>
                </c:pt>
                <c:pt idx="14">
                  <c:v>SEX</c:v>
                </c:pt>
              </c:strCache>
            </c:strRef>
          </c:cat>
          <c:val>
            <c:numRef>
              <c:f>'tästä 030723'!$C$5:$C$19</c:f>
              <c:numCache>
                <c:formatCode>General</c:formatCode>
                <c:ptCount val="15"/>
                <c:pt idx="0">
                  <c:v>0.90900000000000003</c:v>
                </c:pt>
                <c:pt idx="1">
                  <c:v>0.94599999999999995</c:v>
                </c:pt>
                <c:pt idx="2">
                  <c:v>0.96899999999999997</c:v>
                </c:pt>
                <c:pt idx="3">
                  <c:v>0.85</c:v>
                </c:pt>
                <c:pt idx="4">
                  <c:v>0.752</c:v>
                </c:pt>
                <c:pt idx="5">
                  <c:v>0.998</c:v>
                </c:pt>
                <c:pt idx="6">
                  <c:v>0.98699999999999999</c:v>
                </c:pt>
                <c:pt idx="7">
                  <c:v>0.84499999999999997</c:v>
                </c:pt>
                <c:pt idx="8">
                  <c:v>0.877</c:v>
                </c:pt>
                <c:pt idx="9">
                  <c:v>0.89100000000000001</c:v>
                </c:pt>
                <c:pt idx="10">
                  <c:v>0.71399999999999997</c:v>
                </c:pt>
                <c:pt idx="11">
                  <c:v>0.86699999999999999</c:v>
                </c:pt>
                <c:pt idx="12">
                  <c:v>0.873</c:v>
                </c:pt>
                <c:pt idx="13">
                  <c:v>0.77300000000000002</c:v>
                </c:pt>
                <c:pt idx="14">
                  <c:v>0.85599999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503A-4AB6-BA93-ABA4AB719133}"/>
            </c:ext>
          </c:extLst>
        </c:ser>
        <c:ser>
          <c:idx val="1"/>
          <c:order val="1"/>
          <c:tx>
            <c:strRef>
              <c:f>'tästä 030723'!$D$4</c:f>
              <c:strCache>
                <c:ptCount val="1"/>
                <c:pt idx="0">
                  <c:v>6</c:v>
                </c:pt>
              </c:strCache>
            </c:strRef>
          </c:tx>
          <c:spPr>
            <a:ln w="28575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ysClr val="windowText" lastClr="000000"/>
                </a:solidFill>
                <a:prstDash val="sysDot"/>
              </a:ln>
              <a:effectLst/>
            </c:spPr>
          </c:marker>
          <c:cat>
            <c:strRef>
              <c:f>'tästä 030723'!$B$5:$B$19</c:f>
              <c:strCache>
                <c:ptCount val="15"/>
                <c:pt idx="0">
                  <c:v>MOVE</c:v>
                </c:pt>
                <c:pt idx="1">
                  <c:v>SEE*</c:v>
                </c:pt>
                <c:pt idx="2">
                  <c:v>HEAR</c:v>
                </c:pt>
                <c:pt idx="3">
                  <c:v>BREATH</c:v>
                </c:pt>
                <c:pt idx="4">
                  <c:v>SLEEP*</c:v>
                </c:pt>
                <c:pt idx="5">
                  <c:v>EAT</c:v>
                </c:pt>
                <c:pt idx="6">
                  <c:v>SPEECH</c:v>
                </c:pt>
                <c:pt idx="7">
                  <c:v>EXCRET</c:v>
                </c:pt>
                <c:pt idx="8">
                  <c:v>UACT</c:v>
                </c:pt>
                <c:pt idx="9">
                  <c:v>MENTAL</c:v>
                </c:pt>
                <c:pt idx="10">
                  <c:v>DISCO</c:v>
                </c:pt>
                <c:pt idx="11">
                  <c:v>DEPR</c:v>
                </c:pt>
                <c:pt idx="12">
                  <c:v>DISTR</c:v>
                </c:pt>
                <c:pt idx="13">
                  <c:v>VITAL**</c:v>
                </c:pt>
                <c:pt idx="14">
                  <c:v>SEX</c:v>
                </c:pt>
              </c:strCache>
            </c:strRef>
          </c:cat>
          <c:val>
            <c:numRef>
              <c:f>'tästä 030723'!$D$5:$D$19</c:f>
              <c:numCache>
                <c:formatCode>General</c:formatCode>
                <c:ptCount val="15"/>
                <c:pt idx="0">
                  <c:v>0.90400000000000003</c:v>
                </c:pt>
                <c:pt idx="1">
                  <c:v>0.96</c:v>
                </c:pt>
                <c:pt idx="2">
                  <c:v>0.96399999999999997</c:v>
                </c:pt>
                <c:pt idx="3">
                  <c:v>0.83</c:v>
                </c:pt>
                <c:pt idx="4">
                  <c:v>0.78500000000000003</c:v>
                </c:pt>
                <c:pt idx="5">
                  <c:v>1</c:v>
                </c:pt>
                <c:pt idx="6">
                  <c:v>0.98399999999999999</c:v>
                </c:pt>
                <c:pt idx="7">
                  <c:v>0.873</c:v>
                </c:pt>
                <c:pt idx="8">
                  <c:v>0.88300000000000001</c:v>
                </c:pt>
                <c:pt idx="9">
                  <c:v>0.89900000000000002</c:v>
                </c:pt>
                <c:pt idx="10">
                  <c:v>0.69499999999999995</c:v>
                </c:pt>
                <c:pt idx="11">
                  <c:v>0.88200000000000001</c:v>
                </c:pt>
                <c:pt idx="12">
                  <c:v>0.877</c:v>
                </c:pt>
                <c:pt idx="13">
                  <c:v>0.80200000000000005</c:v>
                </c:pt>
                <c:pt idx="14">
                  <c:v>0.867999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503A-4AB6-BA93-ABA4AB719133}"/>
            </c:ext>
          </c:extLst>
        </c:ser>
        <c:ser>
          <c:idx val="2"/>
          <c:order val="2"/>
          <c:tx>
            <c:strRef>
              <c:f>'tästä 030723'!$E$4</c:f>
              <c:strCache>
                <c:ptCount val="1"/>
                <c:pt idx="0">
                  <c:v>12</c:v>
                </c:pt>
              </c:strCache>
            </c:strRef>
          </c:tx>
          <c:spPr>
            <a:ln w="28575" cap="rnd">
              <a:solidFill>
                <a:schemeClr val="bg1">
                  <a:lumMod val="50000"/>
                </a:schemeClr>
              </a:solidFill>
              <a:prstDash val="sysDash"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bg1">
                    <a:lumMod val="50000"/>
                  </a:schemeClr>
                </a:solidFill>
                <a:prstDash val="sysDash"/>
              </a:ln>
              <a:effectLst/>
            </c:spPr>
          </c:marker>
          <c:cat>
            <c:strRef>
              <c:f>'tästä 030723'!$B$5:$B$19</c:f>
              <c:strCache>
                <c:ptCount val="15"/>
                <c:pt idx="0">
                  <c:v>MOVE</c:v>
                </c:pt>
                <c:pt idx="1">
                  <c:v>SEE*</c:v>
                </c:pt>
                <c:pt idx="2">
                  <c:v>HEAR</c:v>
                </c:pt>
                <c:pt idx="3">
                  <c:v>BREATH</c:v>
                </c:pt>
                <c:pt idx="4">
                  <c:v>SLEEP*</c:v>
                </c:pt>
                <c:pt idx="5">
                  <c:v>EAT</c:v>
                </c:pt>
                <c:pt idx="6">
                  <c:v>SPEECH</c:v>
                </c:pt>
                <c:pt idx="7">
                  <c:v>EXCRET</c:v>
                </c:pt>
                <c:pt idx="8">
                  <c:v>UACT</c:v>
                </c:pt>
                <c:pt idx="9">
                  <c:v>MENTAL</c:v>
                </c:pt>
                <c:pt idx="10">
                  <c:v>DISCO</c:v>
                </c:pt>
                <c:pt idx="11">
                  <c:v>DEPR</c:v>
                </c:pt>
                <c:pt idx="12">
                  <c:v>DISTR</c:v>
                </c:pt>
                <c:pt idx="13">
                  <c:v>VITAL**</c:v>
                </c:pt>
                <c:pt idx="14">
                  <c:v>SEX</c:v>
                </c:pt>
              </c:strCache>
            </c:strRef>
          </c:cat>
          <c:val>
            <c:numRef>
              <c:f>'tästä 030723'!$E$5:$E$19</c:f>
              <c:numCache>
                <c:formatCode>General</c:formatCode>
                <c:ptCount val="15"/>
                <c:pt idx="0">
                  <c:v>0.89900000000000002</c:v>
                </c:pt>
                <c:pt idx="1">
                  <c:v>0.96</c:v>
                </c:pt>
                <c:pt idx="2">
                  <c:v>0.96299999999999997</c:v>
                </c:pt>
                <c:pt idx="3">
                  <c:v>0.85199999999999998</c:v>
                </c:pt>
                <c:pt idx="4">
                  <c:v>0.79300000000000004</c:v>
                </c:pt>
                <c:pt idx="5">
                  <c:v>1</c:v>
                </c:pt>
                <c:pt idx="6">
                  <c:v>0.98299999999999998</c:v>
                </c:pt>
                <c:pt idx="7">
                  <c:v>0.873</c:v>
                </c:pt>
                <c:pt idx="8">
                  <c:v>0.88500000000000001</c:v>
                </c:pt>
                <c:pt idx="9">
                  <c:v>0.9</c:v>
                </c:pt>
                <c:pt idx="10">
                  <c:v>0.73</c:v>
                </c:pt>
                <c:pt idx="11">
                  <c:v>0.89100000000000001</c:v>
                </c:pt>
                <c:pt idx="12">
                  <c:v>0.879</c:v>
                </c:pt>
                <c:pt idx="13">
                  <c:v>0.81899999999999995</c:v>
                </c:pt>
                <c:pt idx="14">
                  <c:v>0.8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503A-4AB6-BA93-ABA4AB719133}"/>
            </c:ext>
          </c:extLst>
        </c:ser>
        <c:ser>
          <c:idx val="3"/>
          <c:order val="3"/>
          <c:tx>
            <c:strRef>
              <c:f>'tästä 030723'!$F$4</c:f>
              <c:strCache>
                <c:ptCount val="1"/>
                <c:pt idx="0">
                  <c:v>24</c:v>
                </c:pt>
              </c:strCache>
            </c:strRef>
          </c:tx>
          <c:spPr>
            <a:ln w="28575" cap="rnd" cmpd="dbl">
              <a:solidFill>
                <a:schemeClr val="tx1"/>
              </a:solidFill>
              <a:prstDash val="solid"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  <a:prstDash val="solid"/>
              </a:ln>
              <a:effectLst/>
            </c:spPr>
          </c:marker>
          <c:cat>
            <c:strRef>
              <c:f>'tästä 030723'!$B$5:$B$19</c:f>
              <c:strCache>
                <c:ptCount val="15"/>
                <c:pt idx="0">
                  <c:v>MOVE</c:v>
                </c:pt>
                <c:pt idx="1">
                  <c:v>SEE*</c:v>
                </c:pt>
                <c:pt idx="2">
                  <c:v>HEAR</c:v>
                </c:pt>
                <c:pt idx="3">
                  <c:v>BREATH</c:v>
                </c:pt>
                <c:pt idx="4">
                  <c:v>SLEEP*</c:v>
                </c:pt>
                <c:pt idx="5">
                  <c:v>EAT</c:v>
                </c:pt>
                <c:pt idx="6">
                  <c:v>SPEECH</c:v>
                </c:pt>
                <c:pt idx="7">
                  <c:v>EXCRET</c:v>
                </c:pt>
                <c:pt idx="8">
                  <c:v>UACT</c:v>
                </c:pt>
                <c:pt idx="9">
                  <c:v>MENTAL</c:v>
                </c:pt>
                <c:pt idx="10">
                  <c:v>DISCO</c:v>
                </c:pt>
                <c:pt idx="11">
                  <c:v>DEPR</c:v>
                </c:pt>
                <c:pt idx="12">
                  <c:v>DISTR</c:v>
                </c:pt>
                <c:pt idx="13">
                  <c:v>VITAL**</c:v>
                </c:pt>
                <c:pt idx="14">
                  <c:v>SEX</c:v>
                </c:pt>
              </c:strCache>
            </c:strRef>
          </c:cat>
          <c:val>
            <c:numRef>
              <c:f>'tästä 030723'!$F$5:$F$19</c:f>
              <c:numCache>
                <c:formatCode>General</c:formatCode>
                <c:ptCount val="15"/>
                <c:pt idx="0">
                  <c:v>0.90100000000000002</c:v>
                </c:pt>
                <c:pt idx="1">
                  <c:v>0.97599999999999998</c:v>
                </c:pt>
                <c:pt idx="2">
                  <c:v>0.96599999999999997</c:v>
                </c:pt>
                <c:pt idx="3">
                  <c:v>0.83399999999999996</c:v>
                </c:pt>
                <c:pt idx="4">
                  <c:v>0.79300000000000004</c:v>
                </c:pt>
                <c:pt idx="5">
                  <c:v>0.997</c:v>
                </c:pt>
                <c:pt idx="6">
                  <c:v>0.98699999999999999</c:v>
                </c:pt>
                <c:pt idx="7">
                  <c:v>0.871</c:v>
                </c:pt>
                <c:pt idx="8">
                  <c:v>0.874</c:v>
                </c:pt>
                <c:pt idx="9">
                  <c:v>0.89</c:v>
                </c:pt>
                <c:pt idx="10">
                  <c:v>0.70599999999999996</c:v>
                </c:pt>
                <c:pt idx="11">
                  <c:v>0.87</c:v>
                </c:pt>
                <c:pt idx="12">
                  <c:v>0.88700000000000001</c:v>
                </c:pt>
                <c:pt idx="13">
                  <c:v>0.81399999999999995</c:v>
                </c:pt>
                <c:pt idx="14">
                  <c:v>0.845999999999999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503A-4AB6-BA93-ABA4AB71913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11174488"/>
        <c:axId val="511170880"/>
      </c:lineChart>
      <c:catAx>
        <c:axId val="5111744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i-FI"/>
          </a:p>
        </c:txPr>
        <c:crossAx val="511170880"/>
        <c:crosses val="autoZero"/>
        <c:auto val="1"/>
        <c:lblAlgn val="ctr"/>
        <c:lblOffset val="100"/>
        <c:noMultiLvlLbl val="0"/>
      </c:catAx>
      <c:valAx>
        <c:axId val="511170880"/>
        <c:scaling>
          <c:orientation val="minMax"/>
          <c:max val="1"/>
          <c:min val="0.60000000000000009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i-FI"/>
          </a:p>
        </c:txPr>
        <c:crossAx val="511174488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solidFill>
            <a:schemeClr val="bg1">
              <a:lumMod val="50000"/>
            </a:schemeClr>
          </a:solidFill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i-FI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i-FI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fi-FI" dirty="0" err="1"/>
              <a:t>High</a:t>
            </a:r>
            <a:r>
              <a:rPr lang="fi-FI" dirty="0"/>
              <a:t> SRH (n=83)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i-FI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tästä 030723'!$C$24</c:f>
              <c:strCache>
                <c:ptCount val="1"/>
                <c:pt idx="0">
                  <c:v>0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prstDash val="sysDot"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19050">
                <a:solidFill>
                  <a:sysClr val="windowText" lastClr="000000"/>
                </a:solidFill>
                <a:prstDash val="sysDot"/>
              </a:ln>
              <a:effectLst/>
            </c:spPr>
          </c:marker>
          <c:cat>
            <c:strRef>
              <c:f>'tästä 030723'!$B$25:$B$39</c:f>
              <c:strCache>
                <c:ptCount val="15"/>
                <c:pt idx="0">
                  <c:v>MOVE</c:v>
                </c:pt>
                <c:pt idx="1">
                  <c:v>SEE</c:v>
                </c:pt>
                <c:pt idx="2">
                  <c:v>HEAR</c:v>
                </c:pt>
                <c:pt idx="3">
                  <c:v>BREATH</c:v>
                </c:pt>
                <c:pt idx="4">
                  <c:v>SLEEP</c:v>
                </c:pt>
                <c:pt idx="5">
                  <c:v>EAT</c:v>
                </c:pt>
                <c:pt idx="6">
                  <c:v>SPEECH</c:v>
                </c:pt>
                <c:pt idx="7">
                  <c:v>EXCRET</c:v>
                </c:pt>
                <c:pt idx="8">
                  <c:v>UACT</c:v>
                </c:pt>
                <c:pt idx="9">
                  <c:v>MENTAL</c:v>
                </c:pt>
                <c:pt idx="10">
                  <c:v>DISCO*</c:v>
                </c:pt>
                <c:pt idx="11">
                  <c:v>DEPR</c:v>
                </c:pt>
                <c:pt idx="12">
                  <c:v>DISTR</c:v>
                </c:pt>
                <c:pt idx="13">
                  <c:v>VITAL</c:v>
                </c:pt>
                <c:pt idx="14">
                  <c:v>SEX</c:v>
                </c:pt>
              </c:strCache>
            </c:strRef>
          </c:cat>
          <c:val>
            <c:numRef>
              <c:f>'tästä 030723'!$C$25:$C$39</c:f>
              <c:numCache>
                <c:formatCode>General</c:formatCode>
                <c:ptCount val="15"/>
                <c:pt idx="0">
                  <c:v>0.96199999999999997</c:v>
                </c:pt>
                <c:pt idx="1">
                  <c:v>0.97399999999999998</c:v>
                </c:pt>
                <c:pt idx="2">
                  <c:v>0.96099999999999997</c:v>
                </c:pt>
                <c:pt idx="3">
                  <c:v>0.91100000000000003</c:v>
                </c:pt>
                <c:pt idx="4">
                  <c:v>0.81299999999999994</c:v>
                </c:pt>
                <c:pt idx="5">
                  <c:v>1</c:v>
                </c:pt>
                <c:pt idx="6">
                  <c:v>0.98199999999999998</c:v>
                </c:pt>
                <c:pt idx="7">
                  <c:v>0.88</c:v>
                </c:pt>
                <c:pt idx="8">
                  <c:v>0.96299999999999997</c:v>
                </c:pt>
                <c:pt idx="9">
                  <c:v>0.94399999999999995</c:v>
                </c:pt>
                <c:pt idx="10">
                  <c:v>0.80600000000000005</c:v>
                </c:pt>
                <c:pt idx="11">
                  <c:v>0.92400000000000004</c:v>
                </c:pt>
                <c:pt idx="12">
                  <c:v>0.91700000000000004</c:v>
                </c:pt>
                <c:pt idx="13">
                  <c:v>0.84699999999999998</c:v>
                </c:pt>
                <c:pt idx="14">
                  <c:v>0.9429999999999999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8266-431F-892D-B9F37F66EAF7}"/>
            </c:ext>
          </c:extLst>
        </c:ser>
        <c:ser>
          <c:idx val="1"/>
          <c:order val="1"/>
          <c:tx>
            <c:strRef>
              <c:f>'tästä 030723'!$D$24</c:f>
              <c:strCache>
                <c:ptCount val="1"/>
                <c:pt idx="0">
                  <c:v>6</c:v>
                </c:pt>
              </c:strCache>
            </c:strRef>
          </c:tx>
          <c:spPr>
            <a:ln w="28575" cap="rnd">
              <a:solidFill>
                <a:sysClr val="windowText" lastClr="000000"/>
              </a:solidFill>
              <a:prstDash val="sysDot"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ysClr val="windowText" lastClr="000000"/>
                </a:solidFill>
                <a:prstDash val="sysDot"/>
              </a:ln>
              <a:effectLst/>
            </c:spPr>
          </c:marker>
          <c:cat>
            <c:strRef>
              <c:f>'tästä 030723'!$B$25:$B$39</c:f>
              <c:strCache>
                <c:ptCount val="15"/>
                <c:pt idx="0">
                  <c:v>MOVE</c:v>
                </c:pt>
                <c:pt idx="1">
                  <c:v>SEE</c:v>
                </c:pt>
                <c:pt idx="2">
                  <c:v>HEAR</c:v>
                </c:pt>
                <c:pt idx="3">
                  <c:v>BREATH</c:v>
                </c:pt>
                <c:pt idx="4">
                  <c:v>SLEEP</c:v>
                </c:pt>
                <c:pt idx="5">
                  <c:v>EAT</c:v>
                </c:pt>
                <c:pt idx="6">
                  <c:v>SPEECH</c:v>
                </c:pt>
                <c:pt idx="7">
                  <c:v>EXCRET</c:v>
                </c:pt>
                <c:pt idx="8">
                  <c:v>UACT</c:v>
                </c:pt>
                <c:pt idx="9">
                  <c:v>MENTAL</c:v>
                </c:pt>
                <c:pt idx="10">
                  <c:v>DISCO*</c:v>
                </c:pt>
                <c:pt idx="11">
                  <c:v>DEPR</c:v>
                </c:pt>
                <c:pt idx="12">
                  <c:v>DISTR</c:v>
                </c:pt>
                <c:pt idx="13">
                  <c:v>VITAL</c:v>
                </c:pt>
                <c:pt idx="14">
                  <c:v>SEX</c:v>
                </c:pt>
              </c:strCache>
            </c:strRef>
          </c:cat>
          <c:val>
            <c:numRef>
              <c:f>'tästä 030723'!$D$25:$D$39</c:f>
              <c:numCache>
                <c:formatCode>General</c:formatCode>
                <c:ptCount val="15"/>
                <c:pt idx="0">
                  <c:v>0.93799999999999994</c:v>
                </c:pt>
                <c:pt idx="1">
                  <c:v>0.97499999999999998</c:v>
                </c:pt>
                <c:pt idx="2">
                  <c:v>0.97199999999999998</c:v>
                </c:pt>
                <c:pt idx="3">
                  <c:v>0.90100000000000002</c:v>
                </c:pt>
                <c:pt idx="4">
                  <c:v>0.84699999999999998</c:v>
                </c:pt>
                <c:pt idx="5">
                  <c:v>1</c:v>
                </c:pt>
                <c:pt idx="6">
                  <c:v>0.99099999999999999</c:v>
                </c:pt>
                <c:pt idx="7">
                  <c:v>0.92700000000000005</c:v>
                </c:pt>
                <c:pt idx="8">
                  <c:v>0.94</c:v>
                </c:pt>
                <c:pt idx="9">
                  <c:v>0.93300000000000005</c:v>
                </c:pt>
                <c:pt idx="10">
                  <c:v>0.76</c:v>
                </c:pt>
                <c:pt idx="11">
                  <c:v>0.89800000000000002</c:v>
                </c:pt>
                <c:pt idx="12">
                  <c:v>0.89200000000000002</c:v>
                </c:pt>
                <c:pt idx="13">
                  <c:v>0.84899999999999998</c:v>
                </c:pt>
                <c:pt idx="14">
                  <c:v>0.919000000000000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8266-431F-892D-B9F37F66EAF7}"/>
            </c:ext>
          </c:extLst>
        </c:ser>
        <c:ser>
          <c:idx val="2"/>
          <c:order val="2"/>
          <c:tx>
            <c:strRef>
              <c:f>'tästä 030723'!$E$24</c:f>
              <c:strCache>
                <c:ptCount val="1"/>
                <c:pt idx="0">
                  <c:v>12</c:v>
                </c:pt>
              </c:strCache>
            </c:strRef>
          </c:tx>
          <c:spPr>
            <a:ln w="28575" cap="rnd">
              <a:solidFill>
                <a:schemeClr val="bg1">
                  <a:lumMod val="50000"/>
                </a:schemeClr>
              </a:solidFill>
              <a:prstDash val="dash"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bg1">
                    <a:lumMod val="50000"/>
                  </a:schemeClr>
                </a:solidFill>
                <a:prstDash val="dash"/>
              </a:ln>
              <a:effectLst/>
            </c:spPr>
          </c:marker>
          <c:cat>
            <c:strRef>
              <c:f>'tästä 030723'!$B$25:$B$39</c:f>
              <c:strCache>
                <c:ptCount val="15"/>
                <c:pt idx="0">
                  <c:v>MOVE</c:v>
                </c:pt>
                <c:pt idx="1">
                  <c:v>SEE</c:v>
                </c:pt>
                <c:pt idx="2">
                  <c:v>HEAR</c:v>
                </c:pt>
                <c:pt idx="3">
                  <c:v>BREATH</c:v>
                </c:pt>
                <c:pt idx="4">
                  <c:v>SLEEP</c:v>
                </c:pt>
                <c:pt idx="5">
                  <c:v>EAT</c:v>
                </c:pt>
                <c:pt idx="6">
                  <c:v>SPEECH</c:v>
                </c:pt>
                <c:pt idx="7">
                  <c:v>EXCRET</c:v>
                </c:pt>
                <c:pt idx="8">
                  <c:v>UACT</c:v>
                </c:pt>
                <c:pt idx="9">
                  <c:v>MENTAL</c:v>
                </c:pt>
                <c:pt idx="10">
                  <c:v>DISCO*</c:v>
                </c:pt>
                <c:pt idx="11">
                  <c:v>DEPR</c:v>
                </c:pt>
                <c:pt idx="12">
                  <c:v>DISTR</c:v>
                </c:pt>
                <c:pt idx="13">
                  <c:v>VITAL</c:v>
                </c:pt>
                <c:pt idx="14">
                  <c:v>SEX</c:v>
                </c:pt>
              </c:strCache>
            </c:strRef>
          </c:cat>
          <c:val>
            <c:numRef>
              <c:f>'tästä 030723'!$E$25:$E$39</c:f>
              <c:numCache>
                <c:formatCode>General</c:formatCode>
                <c:ptCount val="15"/>
                <c:pt idx="0">
                  <c:v>0.95699999999999996</c:v>
                </c:pt>
                <c:pt idx="1">
                  <c:v>0.98299999999999998</c:v>
                </c:pt>
                <c:pt idx="2">
                  <c:v>0.96199999999999997</c:v>
                </c:pt>
                <c:pt idx="3">
                  <c:v>0.89600000000000002</c:v>
                </c:pt>
                <c:pt idx="4">
                  <c:v>0.85299999999999998</c:v>
                </c:pt>
                <c:pt idx="5">
                  <c:v>1</c:v>
                </c:pt>
                <c:pt idx="6">
                  <c:v>0.98899999999999999</c:v>
                </c:pt>
                <c:pt idx="7">
                  <c:v>0.91900000000000004</c:v>
                </c:pt>
                <c:pt idx="8">
                  <c:v>0.96299999999999997</c:v>
                </c:pt>
                <c:pt idx="9">
                  <c:v>0.95499999999999996</c:v>
                </c:pt>
                <c:pt idx="10">
                  <c:v>0.79900000000000004</c:v>
                </c:pt>
                <c:pt idx="11">
                  <c:v>0.91100000000000003</c:v>
                </c:pt>
                <c:pt idx="12">
                  <c:v>0.90900000000000003</c:v>
                </c:pt>
                <c:pt idx="13">
                  <c:v>0.871</c:v>
                </c:pt>
                <c:pt idx="14">
                  <c:v>0.953999999999999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8266-431F-892D-B9F37F66EAF7}"/>
            </c:ext>
          </c:extLst>
        </c:ser>
        <c:ser>
          <c:idx val="3"/>
          <c:order val="3"/>
          <c:tx>
            <c:strRef>
              <c:f>'tästä 030723'!$F$24</c:f>
              <c:strCache>
                <c:ptCount val="1"/>
                <c:pt idx="0">
                  <c:v>24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19050">
                <a:solidFill>
                  <a:schemeClr val="tx1"/>
                </a:solidFill>
              </a:ln>
              <a:effectLst/>
            </c:spPr>
          </c:marker>
          <c:cat>
            <c:strRef>
              <c:f>'tästä 030723'!$B$25:$B$39</c:f>
              <c:strCache>
                <c:ptCount val="15"/>
                <c:pt idx="0">
                  <c:v>MOVE</c:v>
                </c:pt>
                <c:pt idx="1">
                  <c:v>SEE</c:v>
                </c:pt>
                <c:pt idx="2">
                  <c:v>HEAR</c:v>
                </c:pt>
                <c:pt idx="3">
                  <c:v>BREATH</c:v>
                </c:pt>
                <c:pt idx="4">
                  <c:v>SLEEP</c:v>
                </c:pt>
                <c:pt idx="5">
                  <c:v>EAT</c:v>
                </c:pt>
                <c:pt idx="6">
                  <c:v>SPEECH</c:v>
                </c:pt>
                <c:pt idx="7">
                  <c:v>EXCRET</c:v>
                </c:pt>
                <c:pt idx="8">
                  <c:v>UACT</c:v>
                </c:pt>
                <c:pt idx="9">
                  <c:v>MENTAL</c:v>
                </c:pt>
                <c:pt idx="10">
                  <c:v>DISCO*</c:v>
                </c:pt>
                <c:pt idx="11">
                  <c:v>DEPR</c:v>
                </c:pt>
                <c:pt idx="12">
                  <c:v>DISTR</c:v>
                </c:pt>
                <c:pt idx="13">
                  <c:v>VITAL</c:v>
                </c:pt>
                <c:pt idx="14">
                  <c:v>SEX</c:v>
                </c:pt>
              </c:strCache>
            </c:strRef>
          </c:cat>
          <c:val>
            <c:numRef>
              <c:f>'tästä 030723'!$F$25:$F$39</c:f>
              <c:numCache>
                <c:formatCode>General</c:formatCode>
                <c:ptCount val="15"/>
                <c:pt idx="0">
                  <c:v>0.95</c:v>
                </c:pt>
                <c:pt idx="1">
                  <c:v>0.97299999999999998</c:v>
                </c:pt>
                <c:pt idx="2">
                  <c:v>0.95</c:v>
                </c:pt>
                <c:pt idx="3">
                  <c:v>0.90500000000000003</c:v>
                </c:pt>
                <c:pt idx="4">
                  <c:v>0.84199999999999997</c:v>
                </c:pt>
                <c:pt idx="5">
                  <c:v>1</c:v>
                </c:pt>
                <c:pt idx="6">
                  <c:v>1</c:v>
                </c:pt>
                <c:pt idx="7">
                  <c:v>0.90400000000000003</c:v>
                </c:pt>
                <c:pt idx="8">
                  <c:v>0.95799999999999996</c:v>
                </c:pt>
                <c:pt idx="9">
                  <c:v>0.92700000000000005</c:v>
                </c:pt>
                <c:pt idx="10">
                  <c:v>0.76700000000000002</c:v>
                </c:pt>
                <c:pt idx="11">
                  <c:v>0.89300000000000002</c:v>
                </c:pt>
                <c:pt idx="12">
                  <c:v>0.92100000000000004</c:v>
                </c:pt>
                <c:pt idx="13">
                  <c:v>0.86699999999999999</c:v>
                </c:pt>
                <c:pt idx="14">
                  <c:v>0.9360000000000000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8266-431F-892D-B9F37F66EAF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80134552"/>
        <c:axId val="580137504"/>
      </c:lineChart>
      <c:catAx>
        <c:axId val="5801345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i-FI"/>
          </a:p>
        </c:txPr>
        <c:crossAx val="580137504"/>
        <c:crosses val="autoZero"/>
        <c:auto val="1"/>
        <c:lblAlgn val="ctr"/>
        <c:lblOffset val="100"/>
        <c:noMultiLvlLbl val="0"/>
      </c:catAx>
      <c:valAx>
        <c:axId val="580137504"/>
        <c:scaling>
          <c:orientation val="minMax"/>
          <c:max val="1"/>
          <c:min val="0.70000000000000007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i-FI"/>
          </a:p>
        </c:txPr>
        <c:crossAx val="580134552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i-FI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i-FI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fi-FI" dirty="0" err="1"/>
              <a:t>Low</a:t>
            </a:r>
            <a:r>
              <a:rPr lang="fi-FI" dirty="0"/>
              <a:t> SRH (n=94)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i-FI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tästä 030723'!$C$43</c:f>
              <c:strCache>
                <c:ptCount val="1"/>
                <c:pt idx="0">
                  <c:v>0</c:v>
                </c:pt>
              </c:strCache>
            </c:strRef>
          </c:tx>
          <c:spPr>
            <a:ln w="19050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19050">
                <a:solidFill>
                  <a:schemeClr val="tx1"/>
                </a:solidFill>
                <a:prstDash val="sysDot"/>
              </a:ln>
              <a:effectLst/>
            </c:spPr>
          </c:marker>
          <c:cat>
            <c:strRef>
              <c:f>'tästä 030723'!$B$44:$B$58</c:f>
              <c:strCache>
                <c:ptCount val="15"/>
                <c:pt idx="0">
                  <c:v>MOVE</c:v>
                </c:pt>
                <c:pt idx="1">
                  <c:v>SEE**</c:v>
                </c:pt>
                <c:pt idx="2">
                  <c:v>HEAR</c:v>
                </c:pt>
                <c:pt idx="3">
                  <c:v>BREATH</c:v>
                </c:pt>
                <c:pt idx="4">
                  <c:v>SLEEP</c:v>
                </c:pt>
                <c:pt idx="5">
                  <c:v>EAT</c:v>
                </c:pt>
                <c:pt idx="6">
                  <c:v>SPEECH</c:v>
                </c:pt>
                <c:pt idx="7">
                  <c:v>EXCRET</c:v>
                </c:pt>
                <c:pt idx="8">
                  <c:v>UACT</c:v>
                </c:pt>
                <c:pt idx="9">
                  <c:v>MENTAL</c:v>
                </c:pt>
                <c:pt idx="10">
                  <c:v>DISCO</c:v>
                </c:pt>
                <c:pt idx="11">
                  <c:v>DEPR**</c:v>
                </c:pt>
                <c:pt idx="12">
                  <c:v>DISTR</c:v>
                </c:pt>
                <c:pt idx="13">
                  <c:v>VITAL***</c:v>
                </c:pt>
                <c:pt idx="14">
                  <c:v>SEX</c:v>
                </c:pt>
              </c:strCache>
            </c:strRef>
          </c:cat>
          <c:val>
            <c:numRef>
              <c:f>'tästä 030723'!$C$44:$C$58</c:f>
              <c:numCache>
                <c:formatCode>General</c:formatCode>
                <c:ptCount val="15"/>
                <c:pt idx="0">
                  <c:v>0.86299999999999999</c:v>
                </c:pt>
                <c:pt idx="1">
                  <c:v>0.92</c:v>
                </c:pt>
                <c:pt idx="2">
                  <c:v>0.97099999999999997</c:v>
                </c:pt>
                <c:pt idx="3">
                  <c:v>0.79600000000000004</c:v>
                </c:pt>
                <c:pt idx="4">
                  <c:v>0.69899999999999995</c:v>
                </c:pt>
                <c:pt idx="5">
                  <c:v>0.996</c:v>
                </c:pt>
                <c:pt idx="6">
                  <c:v>0.98499999999999999</c:v>
                </c:pt>
                <c:pt idx="7">
                  <c:v>0.81499999999999995</c:v>
                </c:pt>
                <c:pt idx="8">
                  <c:v>0.80200000000000005</c:v>
                </c:pt>
                <c:pt idx="9">
                  <c:v>0.84399999999999997</c:v>
                </c:pt>
                <c:pt idx="10">
                  <c:v>0.63300000000000001</c:v>
                </c:pt>
                <c:pt idx="11">
                  <c:v>0.81599999999999995</c:v>
                </c:pt>
                <c:pt idx="12">
                  <c:v>0.83299999999999996</c:v>
                </c:pt>
                <c:pt idx="13">
                  <c:v>0.70699999999999996</c:v>
                </c:pt>
                <c:pt idx="14">
                  <c:v>0.7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81F1-489D-A1EE-7D3C049040AF}"/>
            </c:ext>
          </c:extLst>
        </c:ser>
        <c:ser>
          <c:idx val="1"/>
          <c:order val="1"/>
          <c:tx>
            <c:strRef>
              <c:f>'tästä 030723'!$D$43</c:f>
              <c:strCache>
                <c:ptCount val="1"/>
                <c:pt idx="0">
                  <c:v>6</c:v>
                </c:pt>
              </c:strCache>
            </c:strRef>
          </c:tx>
          <c:spPr>
            <a:ln w="28575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28575">
                <a:solidFill>
                  <a:schemeClr val="tx1"/>
                </a:solidFill>
                <a:prstDash val="sysDot"/>
              </a:ln>
              <a:effectLst/>
            </c:spPr>
          </c:marker>
          <c:cat>
            <c:strRef>
              <c:f>'tästä 030723'!$B$44:$B$58</c:f>
              <c:strCache>
                <c:ptCount val="15"/>
                <c:pt idx="0">
                  <c:v>MOVE</c:v>
                </c:pt>
                <c:pt idx="1">
                  <c:v>SEE**</c:v>
                </c:pt>
                <c:pt idx="2">
                  <c:v>HEAR</c:v>
                </c:pt>
                <c:pt idx="3">
                  <c:v>BREATH</c:v>
                </c:pt>
                <c:pt idx="4">
                  <c:v>SLEEP</c:v>
                </c:pt>
                <c:pt idx="5">
                  <c:v>EAT</c:v>
                </c:pt>
                <c:pt idx="6">
                  <c:v>SPEECH</c:v>
                </c:pt>
                <c:pt idx="7">
                  <c:v>EXCRET</c:v>
                </c:pt>
                <c:pt idx="8">
                  <c:v>UACT</c:v>
                </c:pt>
                <c:pt idx="9">
                  <c:v>MENTAL</c:v>
                </c:pt>
                <c:pt idx="10">
                  <c:v>DISCO</c:v>
                </c:pt>
                <c:pt idx="11">
                  <c:v>DEPR**</c:v>
                </c:pt>
                <c:pt idx="12">
                  <c:v>DISTR</c:v>
                </c:pt>
                <c:pt idx="13">
                  <c:v>VITAL***</c:v>
                </c:pt>
                <c:pt idx="14">
                  <c:v>SEX</c:v>
                </c:pt>
              </c:strCache>
            </c:strRef>
          </c:cat>
          <c:val>
            <c:numRef>
              <c:f>'tästä 030723'!$D$44:$D$58</c:f>
              <c:numCache>
                <c:formatCode>General</c:formatCode>
                <c:ptCount val="15"/>
                <c:pt idx="0">
                  <c:v>0.874</c:v>
                </c:pt>
                <c:pt idx="1">
                  <c:v>0.94599999999999995</c:v>
                </c:pt>
                <c:pt idx="2">
                  <c:v>0.95799999999999996</c:v>
                </c:pt>
                <c:pt idx="3">
                  <c:v>0.76600000000000001</c:v>
                </c:pt>
                <c:pt idx="4">
                  <c:v>0.72799999999999998</c:v>
                </c:pt>
                <c:pt idx="5">
                  <c:v>1</c:v>
                </c:pt>
                <c:pt idx="6">
                  <c:v>0.96899999999999997</c:v>
                </c:pt>
                <c:pt idx="7">
                  <c:v>0.82299999999999995</c:v>
                </c:pt>
                <c:pt idx="8">
                  <c:v>0.83099999999999996</c:v>
                </c:pt>
                <c:pt idx="9">
                  <c:v>0.86699999999999999</c:v>
                </c:pt>
                <c:pt idx="10">
                  <c:v>0.63800000000000001</c:v>
                </c:pt>
                <c:pt idx="11">
                  <c:v>0.86799999999999999</c:v>
                </c:pt>
                <c:pt idx="12">
                  <c:v>0.86399999999999999</c:v>
                </c:pt>
                <c:pt idx="13">
                  <c:v>0.75900000000000001</c:v>
                </c:pt>
                <c:pt idx="14">
                  <c:v>0.8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81F1-489D-A1EE-7D3C049040AF}"/>
            </c:ext>
          </c:extLst>
        </c:ser>
        <c:ser>
          <c:idx val="2"/>
          <c:order val="2"/>
          <c:tx>
            <c:strRef>
              <c:f>'tästä 030723'!$E$43</c:f>
              <c:strCache>
                <c:ptCount val="1"/>
                <c:pt idx="0">
                  <c:v>12</c:v>
                </c:pt>
              </c:strCache>
            </c:strRef>
          </c:tx>
          <c:spPr>
            <a:ln w="28575" cap="rnd">
              <a:solidFill>
                <a:schemeClr val="accent3"/>
              </a:solidFill>
              <a:prstDash val="dash"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  <a:prstDash val="dash"/>
              </a:ln>
              <a:effectLst/>
            </c:spPr>
          </c:marker>
          <c:cat>
            <c:strRef>
              <c:f>'tästä 030723'!$B$44:$B$58</c:f>
              <c:strCache>
                <c:ptCount val="15"/>
                <c:pt idx="0">
                  <c:v>MOVE</c:v>
                </c:pt>
                <c:pt idx="1">
                  <c:v>SEE**</c:v>
                </c:pt>
                <c:pt idx="2">
                  <c:v>HEAR</c:v>
                </c:pt>
                <c:pt idx="3">
                  <c:v>BREATH</c:v>
                </c:pt>
                <c:pt idx="4">
                  <c:v>SLEEP</c:v>
                </c:pt>
                <c:pt idx="5">
                  <c:v>EAT</c:v>
                </c:pt>
                <c:pt idx="6">
                  <c:v>SPEECH</c:v>
                </c:pt>
                <c:pt idx="7">
                  <c:v>EXCRET</c:v>
                </c:pt>
                <c:pt idx="8">
                  <c:v>UACT</c:v>
                </c:pt>
                <c:pt idx="9">
                  <c:v>MENTAL</c:v>
                </c:pt>
                <c:pt idx="10">
                  <c:v>DISCO</c:v>
                </c:pt>
                <c:pt idx="11">
                  <c:v>DEPR**</c:v>
                </c:pt>
                <c:pt idx="12">
                  <c:v>DISTR</c:v>
                </c:pt>
                <c:pt idx="13">
                  <c:v>VITAL***</c:v>
                </c:pt>
                <c:pt idx="14">
                  <c:v>SEX</c:v>
                </c:pt>
              </c:strCache>
            </c:strRef>
          </c:cat>
          <c:val>
            <c:numRef>
              <c:f>'tästä 030723'!$E$44:$E$58</c:f>
              <c:numCache>
                <c:formatCode>General</c:formatCode>
                <c:ptCount val="15"/>
                <c:pt idx="0">
                  <c:v>0.84099999999999997</c:v>
                </c:pt>
                <c:pt idx="1">
                  <c:v>0.93700000000000006</c:v>
                </c:pt>
                <c:pt idx="2">
                  <c:v>0.95399999999999996</c:v>
                </c:pt>
                <c:pt idx="3">
                  <c:v>0.80800000000000005</c:v>
                </c:pt>
                <c:pt idx="4">
                  <c:v>0.74299999999999999</c:v>
                </c:pt>
                <c:pt idx="5">
                  <c:v>1</c:v>
                </c:pt>
                <c:pt idx="6">
                  <c:v>0.96699999999999997</c:v>
                </c:pt>
                <c:pt idx="7">
                  <c:v>0.83099999999999996</c:v>
                </c:pt>
                <c:pt idx="8">
                  <c:v>0.81699999999999995</c:v>
                </c:pt>
                <c:pt idx="9">
                  <c:v>0.85599999999999998</c:v>
                </c:pt>
                <c:pt idx="10">
                  <c:v>0.66700000000000004</c:v>
                </c:pt>
                <c:pt idx="11">
                  <c:v>0.877</c:v>
                </c:pt>
                <c:pt idx="12">
                  <c:v>0.85599999999999998</c:v>
                </c:pt>
                <c:pt idx="13">
                  <c:v>0.77500000000000002</c:v>
                </c:pt>
                <c:pt idx="14">
                  <c:v>0.8010000000000000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81F1-489D-A1EE-7D3C049040AF}"/>
            </c:ext>
          </c:extLst>
        </c:ser>
        <c:ser>
          <c:idx val="3"/>
          <c:order val="3"/>
          <c:tx>
            <c:strRef>
              <c:f>'tästä 030723'!$F$43</c:f>
              <c:strCache>
                <c:ptCount val="1"/>
                <c:pt idx="0">
                  <c:v>24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19050">
                <a:solidFill>
                  <a:schemeClr val="tx1"/>
                </a:solidFill>
              </a:ln>
              <a:effectLst/>
            </c:spPr>
          </c:marker>
          <c:cat>
            <c:strRef>
              <c:f>'tästä 030723'!$B$44:$B$58</c:f>
              <c:strCache>
                <c:ptCount val="15"/>
                <c:pt idx="0">
                  <c:v>MOVE</c:v>
                </c:pt>
                <c:pt idx="1">
                  <c:v>SEE**</c:v>
                </c:pt>
                <c:pt idx="2">
                  <c:v>HEAR</c:v>
                </c:pt>
                <c:pt idx="3">
                  <c:v>BREATH</c:v>
                </c:pt>
                <c:pt idx="4">
                  <c:v>SLEEP</c:v>
                </c:pt>
                <c:pt idx="5">
                  <c:v>EAT</c:v>
                </c:pt>
                <c:pt idx="6">
                  <c:v>SPEECH</c:v>
                </c:pt>
                <c:pt idx="7">
                  <c:v>EXCRET</c:v>
                </c:pt>
                <c:pt idx="8">
                  <c:v>UACT</c:v>
                </c:pt>
                <c:pt idx="9">
                  <c:v>MENTAL</c:v>
                </c:pt>
                <c:pt idx="10">
                  <c:v>DISCO</c:v>
                </c:pt>
                <c:pt idx="11">
                  <c:v>DEPR**</c:v>
                </c:pt>
                <c:pt idx="12">
                  <c:v>DISTR</c:v>
                </c:pt>
                <c:pt idx="13">
                  <c:v>VITAL***</c:v>
                </c:pt>
                <c:pt idx="14">
                  <c:v>SEX</c:v>
                </c:pt>
              </c:strCache>
            </c:strRef>
          </c:cat>
          <c:val>
            <c:numRef>
              <c:f>'tästä 030723'!$F$44:$F$58</c:f>
              <c:numCache>
                <c:formatCode>General</c:formatCode>
                <c:ptCount val="15"/>
                <c:pt idx="0">
                  <c:v>0.86499999999999999</c:v>
                </c:pt>
                <c:pt idx="1">
                  <c:v>0.97899999999999998</c:v>
                </c:pt>
                <c:pt idx="2">
                  <c:v>0.96799999999999997</c:v>
                </c:pt>
                <c:pt idx="3">
                  <c:v>0.76800000000000002</c:v>
                </c:pt>
                <c:pt idx="4">
                  <c:v>0.749</c:v>
                </c:pt>
                <c:pt idx="5">
                  <c:v>0.99399999999999999</c:v>
                </c:pt>
                <c:pt idx="6">
                  <c:v>0.96699999999999997</c:v>
                </c:pt>
                <c:pt idx="7">
                  <c:v>0.84199999999999997</c:v>
                </c:pt>
                <c:pt idx="8">
                  <c:v>0.80900000000000005</c:v>
                </c:pt>
                <c:pt idx="9">
                  <c:v>0.84899999999999998</c:v>
                </c:pt>
                <c:pt idx="10">
                  <c:v>0.65100000000000002</c:v>
                </c:pt>
                <c:pt idx="11">
                  <c:v>0.84799999999999998</c:v>
                </c:pt>
                <c:pt idx="12">
                  <c:v>0.85699999999999998</c:v>
                </c:pt>
                <c:pt idx="13">
                  <c:v>0.77100000000000002</c:v>
                </c:pt>
                <c:pt idx="14">
                  <c:v>0.76400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81F1-489D-A1EE-7D3C049040A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78343128"/>
        <c:axId val="578343456"/>
      </c:lineChart>
      <c:catAx>
        <c:axId val="5783431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i-FI"/>
          </a:p>
        </c:txPr>
        <c:crossAx val="578343456"/>
        <c:crosses val="autoZero"/>
        <c:auto val="1"/>
        <c:lblAlgn val="ctr"/>
        <c:lblOffset val="100"/>
        <c:noMultiLvlLbl val="0"/>
      </c:catAx>
      <c:valAx>
        <c:axId val="578343456"/>
        <c:scaling>
          <c:orientation val="minMax"/>
          <c:max val="1"/>
          <c:min val="0.60000000000000009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i-FI"/>
          </a:p>
        </c:txPr>
        <c:crossAx val="578343128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solidFill>
            <a:schemeClr val="tx1"/>
          </a:solidFill>
          <a:prstDash val="sysDot"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i-FI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i-FI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fi-FI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95D92-EAAE-41EB-9FF7-0A0AE0659F33}" type="datetimeFigureOut">
              <a:rPr lang="fi-FI" smtClean="0"/>
              <a:t>9.11.2024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5D28D2-454F-4BAD-B3F6-338D4666EEAD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4468515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95D92-EAAE-41EB-9FF7-0A0AE0659F33}" type="datetimeFigureOut">
              <a:rPr lang="fi-FI" smtClean="0"/>
              <a:t>9.11.2024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5D28D2-454F-4BAD-B3F6-338D4666EEAD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12236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95D92-EAAE-41EB-9FF7-0A0AE0659F33}" type="datetimeFigureOut">
              <a:rPr lang="fi-FI" smtClean="0"/>
              <a:t>9.11.2024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5D28D2-454F-4BAD-B3F6-338D4666EEAD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98030858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59FA9E-CB65-7E5C-0C54-8D063DE5FEF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BBFCCE4-3A99-0321-1DE3-08ADBA91F1B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fi-FI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7B4D93-F9CE-27D5-B299-D7D91250B8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FE9CCE-F870-4750-BF41-3BFB85D93CA6}" type="datetimeFigureOut">
              <a:rPr lang="fi-FI" smtClean="0"/>
              <a:t>9.11.2024</a:t>
            </a:fld>
            <a:endParaRPr lang="fi-FI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5557830-8359-82E2-62DC-87BFB59194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AD191E-BAE0-A598-7115-7290C640E5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EA337-4193-4997-A200-966B6F88C7AF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166536042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8E44F1-148E-6400-4364-4A0342A6DE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D363B10-87F7-7C96-2F50-AC5F095F3A8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7CB647-DE50-4B24-D48D-71E4FB176C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FE9CCE-F870-4750-BF41-3BFB85D93CA6}" type="datetimeFigureOut">
              <a:rPr lang="fi-FI" smtClean="0"/>
              <a:t>9.11.2024</a:t>
            </a:fld>
            <a:endParaRPr lang="fi-FI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8E6433-07DE-29EA-FB70-02926529E3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E1A69C-C002-4203-12F1-754E7A1609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EA337-4193-4997-A200-966B6F88C7AF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602211235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C078AE-32F3-E5B3-8BB3-04B54469A3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BFDC2D9-4B17-B344-C4AF-DD7E944813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D245B7E-1A06-D635-9E64-5E541D3E64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FE9CCE-F870-4750-BF41-3BFB85D93CA6}" type="datetimeFigureOut">
              <a:rPr lang="fi-FI" smtClean="0"/>
              <a:t>9.11.2024</a:t>
            </a:fld>
            <a:endParaRPr lang="fi-FI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87FF1C-F184-7823-A258-E8FD916FD2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477A647-97A6-5115-5886-65051393CE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EA337-4193-4997-A200-966B6F88C7AF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423895565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95E98C-4344-66F7-29E2-0879AD0751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1907174-4067-6EB8-7B83-835C49AFC88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F74CBF2-55E0-1FD9-64EA-BAD989C7F38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DDAA95C-236A-336C-07F7-7D83F8CDED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FE9CCE-F870-4750-BF41-3BFB85D93CA6}" type="datetimeFigureOut">
              <a:rPr lang="fi-FI" smtClean="0"/>
              <a:t>9.11.2024</a:t>
            </a:fld>
            <a:endParaRPr lang="fi-FI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5249D58-3A58-287E-0DC9-94E07D0E66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1E07BF7-B959-2059-CA07-CF62E552FB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EA337-4193-4997-A200-966B6F88C7AF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366392439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BF21A9-DA89-B8FA-5CEB-22B5FE6C36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98F0B53-33DB-101A-9235-FDC235AA8CD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96D1EAA-319A-AC94-C3A2-A42E08EE2CA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8F4C7B5-E62C-1E50-7646-06A43402AE6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4E79704-5D5D-8F62-2EF9-8AEE20217D1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90BD3D0-35B2-E184-A0CD-88C3ABCE64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FE9CCE-F870-4750-BF41-3BFB85D93CA6}" type="datetimeFigureOut">
              <a:rPr lang="fi-FI" smtClean="0"/>
              <a:t>9.11.2024</a:t>
            </a:fld>
            <a:endParaRPr lang="fi-FI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7A62D87-F08D-C9B6-D2EC-3BA0141C34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1B52124-1EF3-2B9C-7821-E092DDD7AA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EA337-4193-4997-A200-966B6F88C7AF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433495881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F34655-FE95-C25C-DF3B-67042652E1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F89C984-94A9-188C-1424-4F2663081D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FE9CCE-F870-4750-BF41-3BFB85D93CA6}" type="datetimeFigureOut">
              <a:rPr lang="fi-FI" smtClean="0"/>
              <a:t>9.11.2024</a:t>
            </a:fld>
            <a:endParaRPr lang="fi-FI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E853F79-6994-765D-9F9C-8255E85E99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9386514-63CF-1207-EAA6-DECE43B0C3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EA337-4193-4997-A200-966B6F88C7AF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345960632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F9A4E65-344A-681F-9DF4-CBF9247DE7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FE9CCE-F870-4750-BF41-3BFB85D93CA6}" type="datetimeFigureOut">
              <a:rPr lang="fi-FI" smtClean="0"/>
              <a:t>9.11.2024</a:t>
            </a:fld>
            <a:endParaRPr lang="fi-FI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0FD7ACE-F44E-178C-468E-9AF6522FD5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94C56AF-5EF7-CE18-4A37-9140C62581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EA337-4193-4997-A200-966B6F88C7AF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522287779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916976-1C0C-C592-2B53-2272522AA4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E52A511-0EAD-ACD3-C608-86307B2D1C4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2174ADD-EE4F-FFD5-0270-BB27F3EDFF9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26B9E01-01E8-C7D4-6B87-32EA06A1D7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FE9CCE-F870-4750-BF41-3BFB85D93CA6}" type="datetimeFigureOut">
              <a:rPr lang="fi-FI" smtClean="0"/>
              <a:t>9.11.2024</a:t>
            </a:fld>
            <a:endParaRPr lang="fi-FI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8F11D1F-4318-E4F0-4DEC-04DED70980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F81B692-9321-84BC-927C-E7B1D2E41D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EA337-4193-4997-A200-966B6F88C7AF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4507955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95D92-EAAE-41EB-9FF7-0A0AE0659F33}" type="datetimeFigureOut">
              <a:rPr lang="fi-FI" smtClean="0"/>
              <a:t>9.11.2024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5D28D2-454F-4BAD-B3F6-338D4666EEAD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20290285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35FA3B-A980-1E76-8EB2-C2C22E8C37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117AA35-0D44-41FB-A810-33C2058D3BB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i-FI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F11C04C-6CA7-5AEE-2AA3-5A563208D75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D0BC925-4798-DB5F-B20C-363986F6B9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FE9CCE-F870-4750-BF41-3BFB85D93CA6}" type="datetimeFigureOut">
              <a:rPr lang="fi-FI" smtClean="0"/>
              <a:t>9.11.2024</a:t>
            </a:fld>
            <a:endParaRPr lang="fi-FI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3AA861E-9900-BBDA-03CB-4631E3AB33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9CA97FF-DABC-130A-D098-9F836DE3C6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EA337-4193-4997-A200-966B6F88C7AF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568022219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2F6008-A95D-38A0-C4D1-151169EFB0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2EF7D48-586A-3DE9-8146-380D03CA626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9AF89F-57D2-B933-1096-B653ECD867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FE9CCE-F870-4750-BF41-3BFB85D93CA6}" type="datetimeFigureOut">
              <a:rPr lang="fi-FI" smtClean="0"/>
              <a:t>9.11.2024</a:t>
            </a:fld>
            <a:endParaRPr lang="fi-FI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D35620-6737-46A3-3887-299EACC773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894F8B-A198-3B8F-496B-93C8EC769F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EA337-4193-4997-A200-966B6F88C7AF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217620476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B2050E5-65E1-105C-C4A7-D6B65B7042F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839C1F5-5851-317C-4316-08EF28165AD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3EDF51-AAF1-7FD2-EDA0-4551E1D13D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FE9CCE-F870-4750-BF41-3BFB85D93CA6}" type="datetimeFigureOut">
              <a:rPr lang="fi-FI" smtClean="0"/>
              <a:t>9.11.2024</a:t>
            </a:fld>
            <a:endParaRPr lang="fi-FI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B16543-FCEA-9A98-B8CF-8581E25D14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0D7093-320D-0752-CA4D-3751906600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EA337-4193-4997-A200-966B6F88C7AF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7399179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95D92-EAAE-41EB-9FF7-0A0AE0659F33}" type="datetimeFigureOut">
              <a:rPr lang="fi-FI" smtClean="0"/>
              <a:t>9.11.2024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5D28D2-454F-4BAD-B3F6-338D4666EEAD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697184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95D92-EAAE-41EB-9FF7-0A0AE0659F33}" type="datetimeFigureOut">
              <a:rPr lang="fi-FI" smtClean="0"/>
              <a:t>9.11.2024</a:t>
            </a:fld>
            <a:endParaRPr lang="fi-F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5D28D2-454F-4BAD-B3F6-338D4666EEAD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6646381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95D92-EAAE-41EB-9FF7-0A0AE0659F33}" type="datetimeFigureOut">
              <a:rPr lang="fi-FI" smtClean="0"/>
              <a:t>9.11.2024</a:t>
            </a:fld>
            <a:endParaRPr lang="fi-FI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5D28D2-454F-4BAD-B3F6-338D4666EEAD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6056055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95D92-EAAE-41EB-9FF7-0A0AE0659F33}" type="datetimeFigureOut">
              <a:rPr lang="fi-FI" smtClean="0"/>
              <a:t>9.11.2024</a:t>
            </a:fld>
            <a:endParaRPr lang="fi-FI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5D28D2-454F-4BAD-B3F6-338D4666EEAD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8855207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95D92-EAAE-41EB-9FF7-0A0AE0659F33}" type="datetimeFigureOut">
              <a:rPr lang="fi-FI" smtClean="0"/>
              <a:t>9.11.2024</a:t>
            </a:fld>
            <a:endParaRPr lang="fi-FI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5D28D2-454F-4BAD-B3F6-338D4666EEAD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40896873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95D92-EAAE-41EB-9FF7-0A0AE0659F33}" type="datetimeFigureOut">
              <a:rPr lang="fi-FI" smtClean="0"/>
              <a:t>9.11.2024</a:t>
            </a:fld>
            <a:endParaRPr lang="fi-F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5D28D2-454F-4BAD-B3F6-338D4666EEAD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7800130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i-FI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95D92-EAAE-41EB-9FF7-0A0AE0659F33}" type="datetimeFigureOut">
              <a:rPr lang="fi-FI" smtClean="0"/>
              <a:t>9.11.2024</a:t>
            </a:fld>
            <a:endParaRPr lang="fi-F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5D28D2-454F-4BAD-B3F6-338D4666EEAD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4204175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095D92-EAAE-41EB-9FF7-0A0AE0659F33}" type="datetimeFigureOut">
              <a:rPr lang="fi-FI" smtClean="0"/>
              <a:t>9.11.2024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5D28D2-454F-4BAD-B3F6-338D4666EEAD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7975067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i-FI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92F4A75-F7BF-6143-10EC-4106C50C5C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ABF3711-F277-6A1C-9CAB-ED22067DE6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6AA141-98AF-D352-3A62-207B21A82DD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FE9CCE-F870-4750-BF41-3BFB85D93CA6}" type="datetimeFigureOut">
              <a:rPr lang="fi-FI" smtClean="0"/>
              <a:t>9.11.2024</a:t>
            </a:fld>
            <a:endParaRPr lang="fi-FI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2EA5A9D-2F0D-E36B-79C9-9658A3D13CD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i-FI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77E352-3453-3922-79B2-B141B0BD467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8EA337-4193-4997-A200-966B6F88C7AF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8696832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i-FI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8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18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1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/>
          <p:cNvCxnSpPr/>
          <p:nvPr/>
        </p:nvCxnSpPr>
        <p:spPr>
          <a:xfrm>
            <a:off x="1607717" y="4003691"/>
            <a:ext cx="9273643" cy="19669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Oval 9"/>
          <p:cNvSpPr/>
          <p:nvPr/>
        </p:nvSpPr>
        <p:spPr>
          <a:xfrm>
            <a:off x="1069675" y="1881051"/>
            <a:ext cx="1111822" cy="914400"/>
          </a:xfrm>
          <a:prstGeom prst="ellipse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fi-FI" sz="1400" dirty="0"/>
              <a:t>Group </a:t>
            </a:r>
            <a:r>
              <a:rPr lang="fi-FI" sz="1400" dirty="0" err="1"/>
              <a:t>meeting</a:t>
            </a:r>
            <a:r>
              <a:rPr lang="fi-FI" sz="1400" dirty="0"/>
              <a:t> x 2</a:t>
            </a:r>
          </a:p>
        </p:txBody>
      </p:sp>
      <p:sp>
        <p:nvSpPr>
          <p:cNvPr id="11" name="Oval 10"/>
          <p:cNvSpPr/>
          <p:nvPr/>
        </p:nvSpPr>
        <p:spPr>
          <a:xfrm>
            <a:off x="3477983" y="1881051"/>
            <a:ext cx="1118221" cy="914400"/>
          </a:xfrm>
          <a:prstGeom prst="ellipse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fi-FI" sz="1400" dirty="0"/>
              <a:t>Group </a:t>
            </a:r>
            <a:r>
              <a:rPr lang="fi-FI" sz="1400" dirty="0" err="1"/>
              <a:t>meeting</a:t>
            </a:r>
            <a:endParaRPr lang="fi-FI" sz="1400" dirty="0"/>
          </a:p>
        </p:txBody>
      </p:sp>
      <p:sp>
        <p:nvSpPr>
          <p:cNvPr id="12" name="Oval 11"/>
          <p:cNvSpPr/>
          <p:nvPr/>
        </p:nvSpPr>
        <p:spPr>
          <a:xfrm>
            <a:off x="5845627" y="1881051"/>
            <a:ext cx="1237043" cy="914400"/>
          </a:xfrm>
          <a:prstGeom prst="ellipse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fi-FI" sz="1400" dirty="0"/>
              <a:t>Group </a:t>
            </a:r>
            <a:r>
              <a:rPr lang="fi-FI" sz="1400" dirty="0" err="1"/>
              <a:t>meeting</a:t>
            </a:r>
            <a:endParaRPr lang="fi-FI" sz="1400" dirty="0"/>
          </a:p>
        </p:txBody>
      </p:sp>
      <p:sp>
        <p:nvSpPr>
          <p:cNvPr id="13" name="Oval 12"/>
          <p:cNvSpPr/>
          <p:nvPr/>
        </p:nvSpPr>
        <p:spPr>
          <a:xfrm>
            <a:off x="10041147" y="1881051"/>
            <a:ext cx="1297413" cy="914400"/>
          </a:xfrm>
          <a:prstGeom prst="ellipse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fi-FI" sz="1400" dirty="0"/>
              <a:t>Group </a:t>
            </a:r>
            <a:r>
              <a:rPr lang="fi-FI" sz="1400" dirty="0" err="1"/>
              <a:t>meeting</a:t>
            </a:r>
            <a:endParaRPr lang="fi-FI" sz="1400" dirty="0"/>
          </a:p>
        </p:txBody>
      </p:sp>
      <p:sp>
        <p:nvSpPr>
          <p:cNvPr id="14" name="TextBox 13"/>
          <p:cNvSpPr txBox="1"/>
          <p:nvPr/>
        </p:nvSpPr>
        <p:spPr>
          <a:xfrm>
            <a:off x="1547096" y="4625466"/>
            <a:ext cx="3751414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600" dirty="0"/>
              <a:t>Online = ACT-</a:t>
            </a:r>
            <a:r>
              <a:rPr lang="fi-FI" sz="1600" dirty="0" err="1"/>
              <a:t>based</a:t>
            </a:r>
            <a:r>
              <a:rPr lang="fi-FI" sz="1600" dirty="0"/>
              <a:t> online </a:t>
            </a:r>
            <a:r>
              <a:rPr lang="fi-FI" sz="1600" dirty="0" err="1"/>
              <a:t>module</a:t>
            </a:r>
            <a:r>
              <a:rPr lang="fi-FI" sz="1600" dirty="0"/>
              <a:t> 6 </a:t>
            </a:r>
            <a:r>
              <a:rPr lang="fi-FI" sz="1600" dirty="0" err="1"/>
              <a:t>weeks</a:t>
            </a:r>
            <a:endParaRPr lang="fi-FI" sz="1600" dirty="0"/>
          </a:p>
          <a:p>
            <a:r>
              <a:rPr lang="fi-FI" sz="1600" dirty="0"/>
              <a:t>P = </a:t>
            </a:r>
            <a:r>
              <a:rPr lang="fi-FI" sz="1600" dirty="0" err="1"/>
              <a:t>phone</a:t>
            </a:r>
            <a:r>
              <a:rPr lang="fi-FI" sz="1600" dirty="0"/>
              <a:t> </a:t>
            </a:r>
            <a:r>
              <a:rPr lang="fi-FI" sz="1600" dirty="0" err="1"/>
              <a:t>call</a:t>
            </a:r>
            <a:r>
              <a:rPr lang="fi-FI" sz="1600" dirty="0"/>
              <a:t> </a:t>
            </a:r>
            <a:r>
              <a:rPr lang="fi-FI" sz="1600" dirty="0" err="1"/>
              <a:t>from</a:t>
            </a:r>
            <a:r>
              <a:rPr lang="fi-FI" sz="1600" dirty="0"/>
              <a:t> </a:t>
            </a:r>
            <a:r>
              <a:rPr lang="fi-FI" sz="1600" dirty="0" err="1"/>
              <a:t>peer</a:t>
            </a:r>
            <a:r>
              <a:rPr lang="fi-FI" sz="1600" dirty="0"/>
              <a:t> tutor</a:t>
            </a:r>
          </a:p>
          <a:p>
            <a:r>
              <a:rPr lang="fi-FI" sz="1600" dirty="0"/>
              <a:t>	</a:t>
            </a:r>
            <a:r>
              <a:rPr lang="fi-FI" sz="1600" dirty="0" err="1"/>
              <a:t>Supported</a:t>
            </a:r>
            <a:r>
              <a:rPr lang="fi-FI" sz="1600" dirty="0"/>
              <a:t> </a:t>
            </a:r>
            <a:r>
              <a:rPr lang="fi-FI" sz="1600" dirty="0" err="1"/>
              <a:t>period</a:t>
            </a:r>
            <a:endParaRPr lang="fi-FI" sz="1600" dirty="0"/>
          </a:p>
          <a:p>
            <a:r>
              <a:rPr lang="fi-FI" sz="1600" dirty="0"/>
              <a:t>	</a:t>
            </a:r>
            <a:r>
              <a:rPr lang="fi-FI" sz="1600" dirty="0" err="1"/>
              <a:t>Self-directed</a:t>
            </a:r>
            <a:r>
              <a:rPr lang="fi-FI" sz="1600" dirty="0"/>
              <a:t> </a:t>
            </a:r>
            <a:r>
              <a:rPr lang="fi-FI" sz="1600" dirty="0" err="1"/>
              <a:t>period</a:t>
            </a:r>
            <a:endParaRPr lang="fi-FI" sz="1600" dirty="0"/>
          </a:p>
          <a:p>
            <a:endParaRPr lang="fi-FI" sz="1600" dirty="0"/>
          </a:p>
        </p:txBody>
      </p:sp>
      <p:sp>
        <p:nvSpPr>
          <p:cNvPr id="15" name="TextBox 14"/>
          <p:cNvSpPr txBox="1"/>
          <p:nvPr/>
        </p:nvSpPr>
        <p:spPr>
          <a:xfrm>
            <a:off x="3557434" y="4147847"/>
            <a:ext cx="9698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sz="1600" dirty="0"/>
              <a:t>6 </a:t>
            </a:r>
            <a:r>
              <a:rPr lang="fi-FI" sz="1600" dirty="0" err="1"/>
              <a:t>months</a:t>
            </a:r>
            <a:endParaRPr lang="fi-FI" sz="1600" dirty="0"/>
          </a:p>
        </p:txBody>
      </p:sp>
      <p:sp>
        <p:nvSpPr>
          <p:cNvPr id="16" name="TextBox 15"/>
          <p:cNvSpPr txBox="1"/>
          <p:nvPr/>
        </p:nvSpPr>
        <p:spPr>
          <a:xfrm>
            <a:off x="1251857" y="4090628"/>
            <a:ext cx="9698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sz="1600" dirty="0"/>
              <a:t>0 </a:t>
            </a:r>
            <a:r>
              <a:rPr lang="fi-FI" sz="1600" dirty="0" err="1"/>
              <a:t>months</a:t>
            </a:r>
            <a:endParaRPr lang="fi-FI" sz="1600" dirty="0"/>
          </a:p>
        </p:txBody>
      </p:sp>
      <p:sp>
        <p:nvSpPr>
          <p:cNvPr id="17" name="TextBox 16"/>
          <p:cNvSpPr txBox="1"/>
          <p:nvPr/>
        </p:nvSpPr>
        <p:spPr>
          <a:xfrm>
            <a:off x="10204781" y="4147847"/>
            <a:ext cx="107401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sz="1600" dirty="0"/>
              <a:t>24 </a:t>
            </a:r>
            <a:r>
              <a:rPr lang="fi-FI" sz="1600" dirty="0" err="1"/>
              <a:t>months</a:t>
            </a:r>
            <a:endParaRPr lang="fi-FI" sz="1600" dirty="0"/>
          </a:p>
        </p:txBody>
      </p:sp>
      <p:sp>
        <p:nvSpPr>
          <p:cNvPr id="18" name="TextBox 17"/>
          <p:cNvSpPr txBox="1"/>
          <p:nvPr/>
        </p:nvSpPr>
        <p:spPr>
          <a:xfrm>
            <a:off x="5834776" y="4147847"/>
            <a:ext cx="107401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sz="1600" dirty="0"/>
              <a:t>12 </a:t>
            </a:r>
            <a:r>
              <a:rPr lang="fi-FI" sz="1600" dirty="0" err="1"/>
              <a:t>months</a:t>
            </a:r>
            <a:endParaRPr lang="fi-FI" sz="1600" dirty="0"/>
          </a:p>
        </p:txBody>
      </p:sp>
      <p:cxnSp>
        <p:nvCxnSpPr>
          <p:cNvPr id="20" name="Straight Connector 19"/>
          <p:cNvCxnSpPr>
            <a:stCxn id="10" idx="4"/>
          </p:cNvCxnSpPr>
          <p:nvPr/>
        </p:nvCxnSpPr>
        <p:spPr>
          <a:xfrm flipH="1">
            <a:off x="1607717" y="2795451"/>
            <a:ext cx="17869" cy="129517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>
            <a:off x="6302828" y="2795451"/>
            <a:ext cx="0" cy="133537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>
            <a:off x="4091940" y="2795451"/>
            <a:ext cx="0" cy="133537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>
            <a:off x="10868296" y="2795451"/>
            <a:ext cx="0" cy="133537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Rectangle 27"/>
          <p:cNvSpPr/>
          <p:nvPr/>
        </p:nvSpPr>
        <p:spPr>
          <a:xfrm>
            <a:off x="1865300" y="2802057"/>
            <a:ext cx="1381920" cy="771584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fi-FI" sz="1600" dirty="0"/>
              <a:t>I Online + feedback </a:t>
            </a:r>
            <a:r>
              <a:rPr lang="fi-FI" sz="1600" dirty="0" err="1"/>
              <a:t>from</a:t>
            </a:r>
            <a:r>
              <a:rPr lang="fi-FI" sz="1600" dirty="0"/>
              <a:t> </a:t>
            </a:r>
            <a:r>
              <a:rPr lang="fi-FI" sz="1600" dirty="0" err="1"/>
              <a:t>peer</a:t>
            </a:r>
            <a:r>
              <a:rPr lang="fi-FI" sz="1600" dirty="0"/>
              <a:t> tutor</a:t>
            </a:r>
          </a:p>
        </p:txBody>
      </p:sp>
      <p:sp>
        <p:nvSpPr>
          <p:cNvPr id="29" name="Rectangle 28"/>
          <p:cNvSpPr/>
          <p:nvPr/>
        </p:nvSpPr>
        <p:spPr>
          <a:xfrm>
            <a:off x="4211301" y="2802058"/>
            <a:ext cx="1416320" cy="771584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lvl="0" algn="ctr"/>
            <a:r>
              <a:rPr lang="fi-FI" sz="1600" dirty="0">
                <a:solidFill>
                  <a:prstClr val="black"/>
                </a:solidFill>
              </a:rPr>
              <a:t>II Online + feedback </a:t>
            </a:r>
            <a:r>
              <a:rPr lang="fi-FI" sz="1600" dirty="0" err="1">
                <a:solidFill>
                  <a:prstClr val="black"/>
                </a:solidFill>
              </a:rPr>
              <a:t>from</a:t>
            </a:r>
            <a:r>
              <a:rPr lang="fi-FI" sz="1600" dirty="0">
                <a:solidFill>
                  <a:prstClr val="black"/>
                </a:solidFill>
              </a:rPr>
              <a:t> </a:t>
            </a:r>
            <a:r>
              <a:rPr lang="fi-FI" sz="1600" dirty="0" err="1">
                <a:solidFill>
                  <a:prstClr val="black"/>
                </a:solidFill>
              </a:rPr>
              <a:t>peer</a:t>
            </a:r>
            <a:r>
              <a:rPr lang="fi-FI" sz="1600" dirty="0">
                <a:solidFill>
                  <a:prstClr val="black"/>
                </a:solidFill>
              </a:rPr>
              <a:t> tutor</a:t>
            </a:r>
          </a:p>
        </p:txBody>
      </p:sp>
      <p:sp>
        <p:nvSpPr>
          <p:cNvPr id="30" name="Rectangle 29"/>
          <p:cNvSpPr/>
          <p:nvPr/>
        </p:nvSpPr>
        <p:spPr>
          <a:xfrm>
            <a:off x="8009452" y="2802058"/>
            <a:ext cx="1126093" cy="771584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fi-FI" sz="1600" dirty="0"/>
              <a:t>III Online</a:t>
            </a:r>
          </a:p>
        </p:txBody>
      </p:sp>
      <p:cxnSp>
        <p:nvCxnSpPr>
          <p:cNvPr id="32" name="Straight Connector 31"/>
          <p:cNvCxnSpPr>
            <a:stCxn id="28" idx="2"/>
          </p:cNvCxnSpPr>
          <p:nvPr/>
        </p:nvCxnSpPr>
        <p:spPr>
          <a:xfrm>
            <a:off x="2556260" y="3573641"/>
            <a:ext cx="1" cy="4563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/>
          <p:cNvCxnSpPr/>
          <p:nvPr/>
        </p:nvCxnSpPr>
        <p:spPr>
          <a:xfrm>
            <a:off x="5045527" y="3593310"/>
            <a:ext cx="6531" cy="43665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/>
          <p:cNvCxnSpPr/>
          <p:nvPr/>
        </p:nvCxnSpPr>
        <p:spPr>
          <a:xfrm>
            <a:off x="8585307" y="3593310"/>
            <a:ext cx="6531" cy="43665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Isosceles Triangle 37"/>
          <p:cNvSpPr/>
          <p:nvPr/>
        </p:nvSpPr>
        <p:spPr>
          <a:xfrm>
            <a:off x="3284520" y="3076323"/>
            <a:ext cx="539261" cy="516987"/>
          </a:xfrm>
          <a:prstGeom prst="triangle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fi-FI" sz="2000" dirty="0"/>
              <a:t>P</a:t>
            </a:r>
          </a:p>
        </p:txBody>
      </p:sp>
      <p:sp>
        <p:nvSpPr>
          <p:cNvPr id="39" name="Isosceles Triangle 38"/>
          <p:cNvSpPr/>
          <p:nvPr/>
        </p:nvSpPr>
        <p:spPr>
          <a:xfrm>
            <a:off x="7082671" y="3076322"/>
            <a:ext cx="539261" cy="516987"/>
          </a:xfrm>
          <a:prstGeom prst="triangle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fi-FI" sz="2000" dirty="0"/>
              <a:t>P</a:t>
            </a:r>
          </a:p>
        </p:txBody>
      </p:sp>
      <p:sp>
        <p:nvSpPr>
          <p:cNvPr id="40" name="Isosceles Triangle 39"/>
          <p:cNvSpPr/>
          <p:nvPr/>
        </p:nvSpPr>
        <p:spPr>
          <a:xfrm>
            <a:off x="5685688" y="3058189"/>
            <a:ext cx="539261" cy="516987"/>
          </a:xfrm>
          <a:prstGeom prst="triangle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fi-FI" sz="2000" dirty="0"/>
              <a:t>P</a:t>
            </a:r>
          </a:p>
        </p:txBody>
      </p:sp>
      <p:sp>
        <p:nvSpPr>
          <p:cNvPr id="41" name="Isosceles Triangle 40"/>
          <p:cNvSpPr/>
          <p:nvPr/>
        </p:nvSpPr>
        <p:spPr>
          <a:xfrm>
            <a:off x="9898390" y="3075606"/>
            <a:ext cx="539261" cy="516987"/>
          </a:xfrm>
          <a:prstGeom prst="triangle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fi-FI" sz="2000" dirty="0"/>
              <a:t>P</a:t>
            </a:r>
          </a:p>
        </p:txBody>
      </p:sp>
      <p:cxnSp>
        <p:nvCxnSpPr>
          <p:cNvPr id="43" name="Straight Connector 42"/>
          <p:cNvCxnSpPr>
            <a:stCxn id="38" idx="3"/>
          </p:cNvCxnSpPr>
          <p:nvPr/>
        </p:nvCxnSpPr>
        <p:spPr>
          <a:xfrm flipH="1">
            <a:off x="3552298" y="3593310"/>
            <a:ext cx="1853" cy="40208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/>
          <p:cNvCxnSpPr/>
          <p:nvPr/>
        </p:nvCxnSpPr>
        <p:spPr>
          <a:xfrm flipH="1">
            <a:off x="5962207" y="3590077"/>
            <a:ext cx="1853" cy="40208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/>
          <p:cNvCxnSpPr/>
          <p:nvPr/>
        </p:nvCxnSpPr>
        <p:spPr>
          <a:xfrm flipH="1">
            <a:off x="7365636" y="3610595"/>
            <a:ext cx="1853" cy="40208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/>
          <p:cNvCxnSpPr/>
          <p:nvPr/>
        </p:nvCxnSpPr>
        <p:spPr>
          <a:xfrm flipH="1">
            <a:off x="10166167" y="3601605"/>
            <a:ext cx="1853" cy="40208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" name="Straight Connector 2"/>
          <p:cNvCxnSpPr>
            <a:cxnSpLocks/>
          </p:cNvCxnSpPr>
          <p:nvPr/>
        </p:nvCxnSpPr>
        <p:spPr>
          <a:xfrm>
            <a:off x="1607716" y="3802648"/>
            <a:ext cx="4682049" cy="0"/>
          </a:xfrm>
          <a:prstGeom prst="line">
            <a:avLst/>
          </a:prstGeom>
          <a:ln w="38100">
            <a:solidFill>
              <a:schemeClr val="tx1"/>
            </a:solidFill>
          </a:ln>
          <a:effectLst>
            <a:innerShdw blurRad="63500" dist="50800" dir="2700000">
              <a:prstClr val="black">
                <a:alpha val="50000"/>
              </a:prstClr>
            </a:innerShdw>
          </a:effectLst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/>
          <p:cNvCxnSpPr/>
          <p:nvPr/>
        </p:nvCxnSpPr>
        <p:spPr>
          <a:xfrm flipV="1">
            <a:off x="6315892" y="3789858"/>
            <a:ext cx="4553000" cy="8990"/>
          </a:xfrm>
          <a:prstGeom prst="line">
            <a:avLst/>
          </a:prstGeom>
          <a:ln w="381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/>
          <p:cNvCxnSpPr/>
          <p:nvPr/>
        </p:nvCxnSpPr>
        <p:spPr>
          <a:xfrm>
            <a:off x="1607717" y="5318537"/>
            <a:ext cx="843377" cy="5128"/>
          </a:xfrm>
          <a:prstGeom prst="line">
            <a:avLst/>
          </a:prstGeom>
          <a:ln w="38100">
            <a:solidFill>
              <a:schemeClr val="tx1"/>
            </a:solidFill>
          </a:ln>
          <a:effectLst>
            <a:innerShdw blurRad="63500" dist="50800" dir="2700000">
              <a:prstClr val="black">
                <a:alpha val="50000"/>
              </a:prstClr>
            </a:innerShdw>
          </a:effectLst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/>
          <p:cNvCxnSpPr/>
          <p:nvPr/>
        </p:nvCxnSpPr>
        <p:spPr>
          <a:xfrm>
            <a:off x="1607716" y="5532056"/>
            <a:ext cx="843377" cy="0"/>
          </a:xfrm>
          <a:prstGeom prst="line">
            <a:avLst/>
          </a:prstGeom>
          <a:ln w="381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>
            <a:extLst>
              <a:ext uri="{FF2B5EF4-FFF2-40B4-BE49-F238E27FC236}">
                <a16:creationId xmlns:a16="http://schemas.microsoft.com/office/drawing/2014/main" id="{91330F82-71FF-7E90-5C35-86E4C967846E}"/>
              </a:ext>
            </a:extLst>
          </p:cNvPr>
          <p:cNvSpPr txBox="1"/>
          <p:nvPr/>
        </p:nvSpPr>
        <p:spPr>
          <a:xfrm>
            <a:off x="1055922" y="6016736"/>
            <a:ext cx="9143397" cy="4633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Aft>
                <a:spcPts val="800"/>
              </a:spcAft>
            </a:pP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 1: Fig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re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1. The 24-month ACT-based lifestyle intervention (Punna et al., 2021).</a:t>
            </a:r>
            <a:endParaRPr lang="fi-FI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339367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875AE271-C5A0-4BF3-A581-0AE99A6A063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21202509"/>
              </p:ext>
            </p:extLst>
          </p:nvPr>
        </p:nvGraphicFramePr>
        <p:xfrm>
          <a:off x="2893806" y="741443"/>
          <a:ext cx="6244590" cy="43453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B7DF1AC3-2264-C60B-9C33-53B3F6AC0780}"/>
              </a:ext>
            </a:extLst>
          </p:cNvPr>
          <p:cNvSpPr txBox="1"/>
          <p:nvPr/>
        </p:nvSpPr>
        <p:spPr>
          <a:xfrm>
            <a:off x="1447059" y="5677109"/>
            <a:ext cx="9596761" cy="8788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Bef>
                <a:spcPts val="1200"/>
              </a:spcBef>
              <a:spcAft>
                <a:spcPts val="800"/>
              </a:spcAft>
            </a:pP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Figure S2.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RQoL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with all the participants. Statistically significant changes expressed with *) 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&lt; .05, and **) 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&lt; .005.</a:t>
            </a:r>
            <a:endParaRPr lang="fi-FI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4142096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3AB9D5CE-AC95-41AB-9094-4F111102FAC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97738566"/>
              </p:ext>
            </p:extLst>
          </p:nvPr>
        </p:nvGraphicFramePr>
        <p:xfrm>
          <a:off x="2955145" y="1069676"/>
          <a:ext cx="6033135" cy="37776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5162AB23-ED88-D272-EC17-4F452DC4FAD8}"/>
              </a:ext>
            </a:extLst>
          </p:cNvPr>
          <p:cNvSpPr txBox="1"/>
          <p:nvPr/>
        </p:nvSpPr>
        <p:spPr>
          <a:xfrm>
            <a:off x="1225118" y="5468728"/>
            <a:ext cx="9691456" cy="8788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Bef>
                <a:spcPts val="1200"/>
              </a:spcBef>
              <a:spcAft>
                <a:spcPts val="800"/>
              </a:spcAft>
            </a:pP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Figure S3.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RQoL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with the group of SRH high.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atistically significant change expressed with *) 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&lt; .05.</a:t>
            </a:r>
            <a:endParaRPr lang="fi-FI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50003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F3568C71-AD91-4D03-A519-60EB0BDC79E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23239552"/>
              </p:ext>
            </p:extLst>
          </p:nvPr>
        </p:nvGraphicFramePr>
        <p:xfrm>
          <a:off x="2744327" y="1100831"/>
          <a:ext cx="6222119" cy="390200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EFED8557-5D71-907B-642E-4CDE0070E0C2}"/>
              </a:ext>
            </a:extLst>
          </p:cNvPr>
          <p:cNvSpPr txBox="1"/>
          <p:nvPr/>
        </p:nvSpPr>
        <p:spPr>
          <a:xfrm>
            <a:off x="1109709" y="5433131"/>
            <a:ext cx="10351363" cy="8788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Bef>
                <a:spcPts val="1200"/>
              </a:spcBef>
              <a:spcAft>
                <a:spcPts val="800"/>
              </a:spcAft>
            </a:pP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 1: </a:t>
            </a:r>
            <a:r>
              <a:rPr lang="en-US" sz="18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4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RQoL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f life with group of SRH low. Statistically significant changes expressed with **) 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&lt; .005, and ***) 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&lt; .001.</a:t>
            </a:r>
            <a:endParaRPr lang="fi-FI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405767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5243</TotalTime>
  <Words>184</Words>
  <Application>Microsoft Office PowerPoint</Application>
  <PresentationFormat>Widescreen</PresentationFormat>
  <Paragraphs>26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1_Office Theme</vt:lpstr>
      <vt:lpstr>PowerPoint Presentation</vt:lpstr>
      <vt:lpstr>PowerPoint Presentation</vt:lpstr>
      <vt:lpstr>PowerPoint Presentation</vt:lpstr>
      <vt:lpstr>PowerPoint Presentation</vt:lpstr>
    </vt:vector>
  </TitlesOfParts>
  <Company>University Of Jyväskylä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unna, Mari</dc:creator>
  <cp:lastModifiedBy>Petäjä, Mari</cp:lastModifiedBy>
  <cp:revision>37</cp:revision>
  <cp:lastPrinted>2023-12-17T13:56:35Z</cp:lastPrinted>
  <dcterms:created xsi:type="dcterms:W3CDTF">2019-10-23T08:32:29Z</dcterms:created>
  <dcterms:modified xsi:type="dcterms:W3CDTF">2024-11-09T14:57:33Z</dcterms:modified>
</cp:coreProperties>
</file>